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12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27" autoAdjust="0"/>
    <p:restoredTop sz="91212" autoAdjust="0"/>
  </p:normalViewPr>
  <p:slideViewPr>
    <p:cSldViewPr snapToGrid="0" showGuides="1">
      <p:cViewPr>
        <p:scale>
          <a:sx n="100" d="100"/>
          <a:sy n="100" d="100"/>
        </p:scale>
        <p:origin x="1880" y="144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k-chs-lneta\QMCR-USERS\sancho01\Exps\PCR\Real%20time%20results\MYC%20PGC1a\summary%20em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Mitochondrial%20inhibition\MYC%20PGC1A%202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Mitochondrial%20inhibition\MYC%20PGC1A%202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Mitochondrial%20inhibition\MYC%20PGC1A%202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242219370742901"/>
          <c:y val="9.3430433607913393E-2"/>
          <c:w val="0.78098749642180798"/>
          <c:h val="0.732464727539803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HPRT 2'!$A$2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ummary HPRT 2'!$Q$8:$Q$11</c:f>
                <c:numCache>
                  <c:formatCode>General</c:formatCode>
                  <c:ptCount val="4"/>
                  <c:pt idx="0">
                    <c:v>5.5997674237349103E-2</c:v>
                  </c:pt>
                  <c:pt idx="1">
                    <c:v>5.3949024535674246</c:v>
                  </c:pt>
                  <c:pt idx="2">
                    <c:v>8.0714459578120304E-2</c:v>
                  </c:pt>
                  <c:pt idx="3">
                    <c:v>1.8588132104368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Summary HPRT 2'!$C$62:$D$65</c:f>
              <c:multiLvlStrCache>
                <c:ptCount val="4"/>
                <c:lvl>
                  <c:pt idx="0">
                    <c:v>NT</c:v>
                  </c:pt>
                  <c:pt idx="1">
                    <c:v>MYC OE</c:v>
                  </c:pt>
                  <c:pt idx="2">
                    <c:v>NT</c:v>
                  </c:pt>
                  <c:pt idx="3">
                    <c:v>MYC OE</c:v>
                  </c:pt>
                </c:lvl>
                <c:lvl>
                  <c:pt idx="0">
                    <c:v>215</c:v>
                  </c:pt>
                  <c:pt idx="2">
                    <c:v>253</c:v>
                  </c:pt>
                </c:lvl>
              </c:multiLvlStrCache>
            </c:multiLvlStrRef>
          </c:cat>
          <c:val>
            <c:numRef>
              <c:f>('Summary HPRT 2'!$P$10,'Summary HPRT 2'!$P$11,'Summary HPRT 2'!$P$8,'Summary HPRT 2'!$P$9)</c:f>
              <c:numCache>
                <c:formatCode>General</c:formatCode>
                <c:ptCount val="4"/>
                <c:pt idx="0">
                  <c:v>1.0033787073364999</c:v>
                </c:pt>
                <c:pt idx="1">
                  <c:v>23.560584272844181</c:v>
                </c:pt>
                <c:pt idx="2">
                  <c:v>1.0015399290480731</c:v>
                </c:pt>
                <c:pt idx="3">
                  <c:v>21.85076305953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43-C342-8D93-A160093C51D0}"/>
            </c:ext>
          </c:extLst>
        </c:ser>
        <c:ser>
          <c:idx val="1"/>
          <c:order val="1"/>
          <c:tx>
            <c:strRef>
              <c:f>'Summary HPRT 2'!$A$13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Summary HPRT 2'!$R$21,'Summary HPRT 2'!$R$22,'Summary HPRT 2'!$R$19,'Summary HPRT 2'!$R$20)</c:f>
                <c:numCache>
                  <c:formatCode>General</c:formatCode>
                  <c:ptCount val="4"/>
                  <c:pt idx="0">
                    <c:v>0.32583488977515401</c:v>
                  </c:pt>
                  <c:pt idx="1">
                    <c:v>37.981803442273772</c:v>
                  </c:pt>
                  <c:pt idx="2">
                    <c:v>3.8792924502311303E-2</c:v>
                  </c:pt>
                  <c:pt idx="3">
                    <c:v>3.55837844816247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Summary HPRT 2'!$C$62:$D$65</c:f>
              <c:multiLvlStrCache>
                <c:ptCount val="4"/>
                <c:lvl>
                  <c:pt idx="0">
                    <c:v>NT</c:v>
                  </c:pt>
                  <c:pt idx="1">
                    <c:v>MYC OE</c:v>
                  </c:pt>
                  <c:pt idx="2">
                    <c:v>NT</c:v>
                  </c:pt>
                  <c:pt idx="3">
                    <c:v>MYC OE</c:v>
                  </c:pt>
                </c:lvl>
                <c:lvl>
                  <c:pt idx="0">
                    <c:v>215</c:v>
                  </c:pt>
                  <c:pt idx="2">
                    <c:v>253</c:v>
                  </c:pt>
                </c:lvl>
              </c:multiLvlStrCache>
            </c:multiLvlStrRef>
          </c:cat>
          <c:val>
            <c:numRef>
              <c:f>('Summary HPRT 2'!$P$21,'Summary HPRT 2'!$P$22,'Summary HPRT 2'!$P$19,'Summary HPRT 2'!$P$20)</c:f>
              <c:numCache>
                <c:formatCode>General</c:formatCode>
                <c:ptCount val="4"/>
                <c:pt idx="0">
                  <c:v>1.0947454045818401</c:v>
                </c:pt>
                <c:pt idx="1">
                  <c:v>67.600819826722017</c:v>
                </c:pt>
                <c:pt idx="2">
                  <c:v>1.0015109521935921</c:v>
                </c:pt>
                <c:pt idx="3">
                  <c:v>33.507187948265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43-C342-8D93-A160093C51D0}"/>
            </c:ext>
          </c:extLst>
        </c:ser>
        <c:ser>
          <c:idx val="2"/>
          <c:order val="2"/>
          <c:tx>
            <c:strRef>
              <c:f>'Summary HPRT 2'!$A$24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ummary HPRT 2'!$Q$30:$Q$33</c:f>
                <c:numCache>
                  <c:formatCode>General</c:formatCode>
                  <c:ptCount val="4"/>
                  <c:pt idx="0">
                    <c:v>0.18824815563898101</c:v>
                  </c:pt>
                  <c:pt idx="1">
                    <c:v>4.5348188023423086</c:v>
                  </c:pt>
                  <c:pt idx="2">
                    <c:v>0.42058299324915299</c:v>
                  </c:pt>
                  <c:pt idx="3">
                    <c:v>12.5315792053028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Summary HPRT 2'!$C$62:$D$65</c:f>
              <c:multiLvlStrCache>
                <c:ptCount val="4"/>
                <c:lvl>
                  <c:pt idx="0">
                    <c:v>NT</c:v>
                  </c:pt>
                  <c:pt idx="1">
                    <c:v>MYC OE</c:v>
                  </c:pt>
                  <c:pt idx="2">
                    <c:v>NT</c:v>
                  </c:pt>
                  <c:pt idx="3">
                    <c:v>MYC OE</c:v>
                  </c:pt>
                </c:lvl>
                <c:lvl>
                  <c:pt idx="0">
                    <c:v>215</c:v>
                  </c:pt>
                  <c:pt idx="2">
                    <c:v>253</c:v>
                  </c:pt>
                </c:lvl>
              </c:multiLvlStrCache>
            </c:multiLvlStrRef>
          </c:cat>
          <c:val>
            <c:numRef>
              <c:f>('Summary HPRT 2'!$P$32,'Summary HPRT 2'!$P$33,'Summary HPRT 2'!$P$30,'Summary HPRT 2'!$P$31)</c:f>
              <c:numCache>
                <c:formatCode>General</c:formatCode>
                <c:ptCount val="4"/>
                <c:pt idx="0">
                  <c:v>1.0710064498368459</c:v>
                </c:pt>
                <c:pt idx="1">
                  <c:v>14.84304499868734</c:v>
                </c:pt>
                <c:pt idx="2">
                  <c:v>1.0192530059978571</c:v>
                </c:pt>
                <c:pt idx="3">
                  <c:v>30.0295543509820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343-C342-8D93-A160093C51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85617120"/>
        <c:axId val="285617680"/>
        <c:extLst>
          <c:ext xmlns:c15="http://schemas.microsoft.com/office/drawing/2012/chart" uri="{02D57815-91ED-43cb-92C2-25804820EDAC}">
            <c15:filteredBarSeries>
              <c15:ser>
                <c:idx val="3"/>
                <c:order val="3"/>
                <c:tx>
                  <c:strRef>
                    <c:extLst>
                      <c:ext uri="{02D57815-91ED-43cb-92C2-25804820EDAC}">
                        <c15:formulaRef>
                          <c15:sqref>'Summary HPRT 2'!$A$35</c15:sqref>
                        </c15:formulaRef>
                      </c:ext>
                    </c:extLst>
                    <c:strCache>
                      <c:ptCount val="1"/>
                      <c:pt idx="0">
                        <c:v>SerpinB3</c:v>
                      </c:pt>
                    </c:strCache>
                  </c:strRef>
                </c:tx>
                <c:spPr>
                  <a:solidFill>
                    <a:schemeClr val="accent4"/>
                  </a:solidFill>
                  <a:ln>
                    <a:noFill/>
                  </a:ln>
                  <a:effectLst/>
                </c:spPr>
                <c:invertIfNegative val="0"/>
                <c:errBars>
                  <c:errBarType val="plus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Summary HPRT 2'!$Q$42:$Q$44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2.367830230598682</c:v>
                        </c:pt>
                        <c:pt idx="1">
                          <c:v>0.32807208040048702</c:v>
                        </c:pt>
                        <c:pt idx="2">
                          <c:v>2.4526782489776342</c:v>
                        </c:pt>
                      </c:numCache>
                    </c:numRef>
                  </c:plus>
                  <c:min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multiLvlStrRef>
                    <c:extLst>
                      <c:ext uri="{02D57815-91ED-43cb-92C2-25804820EDAC}">
                        <c15:formulaRef>
                          <c15:sqref>'Summary HPRT 2'!$C$62:$D$65</c15:sqref>
                        </c15:formulaRef>
                      </c:ext>
                    </c:extLst>
                    <c:multiLvlStrCache>
                      <c:ptCount val="4"/>
                      <c:lvl>
                        <c:pt idx="0">
                          <c:v>NT</c:v>
                        </c:pt>
                        <c:pt idx="1">
                          <c:v>MYC OE</c:v>
                        </c:pt>
                        <c:pt idx="2">
                          <c:v>NT</c:v>
                        </c:pt>
                        <c:pt idx="3">
                          <c:v>MYC OE</c:v>
                        </c:pt>
                      </c:lvl>
                      <c:lvl>
                        <c:pt idx="0">
                          <c:v>215</c:v>
                        </c:pt>
                        <c:pt idx="2">
                          <c:v>253</c:v>
                        </c:pt>
                      </c:lvl>
                    </c:multiLvlStrCache>
                  </c:multiLvlStrRef>
                </c:cat>
                <c:val>
                  <c:numRef>
                    <c:extLst>
                      <c:ext uri="{02D57815-91ED-43cb-92C2-25804820EDAC}">
                        <c15:formulaRef>
                          <c15:sqref>'Summary HPRT 2'!$P$41:$P$44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.046860096449719</c:v>
                      </c:pt>
                      <c:pt idx="1">
                        <c:v>2.3311761964380371</c:v>
                      </c:pt>
                      <c:pt idx="2">
                        <c:v>1.0535195741039081</c:v>
                      </c:pt>
                      <c:pt idx="3">
                        <c:v>4.9892488229359699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3-6343-C342-8D93-A160093C51D0}"/>
                  </c:ext>
                </c:extLst>
              </c15:ser>
            </c15:filteredBarSeries>
            <c15:filteredBa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ummary HPRT 2'!$A$47</c15:sqref>
                        </c15:formulaRef>
                      </c:ext>
                    </c:extLst>
                    <c:strCache>
                      <c:ptCount val="1"/>
                      <c:pt idx="0">
                        <c:v>CXCR4</c:v>
                      </c:pt>
                    </c:strCache>
                  </c:strRef>
                </c:tx>
                <c:spPr>
                  <a:solidFill>
                    <a:schemeClr val="accent5"/>
                  </a:solidFill>
                  <a:ln>
                    <a:noFill/>
                  </a:ln>
                  <a:effectLst/>
                </c:spPr>
                <c:invertIfNegative val="0"/>
                <c:errBars>
                  <c:errBarType val="plus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Summary HPRT 2'!$Q$53:$Q$56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176243638784015</c:v>
                        </c:pt>
                        <c:pt idx="1">
                          <c:v>8.6620359430856393</c:v>
                        </c:pt>
                        <c:pt idx="2">
                          <c:v>0.73205419724610399</c:v>
                        </c:pt>
                        <c:pt idx="3">
                          <c:v>34.332322330453799</c:v>
                        </c:pt>
                      </c:numCache>
                    </c:numRef>
                  </c:plus>
                  <c:min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multiLvl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ummary HPRT 2'!$C$62:$D$65</c15:sqref>
                        </c15:formulaRef>
                      </c:ext>
                    </c:extLst>
                    <c:multiLvlStrCache>
                      <c:ptCount val="4"/>
                      <c:lvl>
                        <c:pt idx="0">
                          <c:v>NT</c:v>
                        </c:pt>
                        <c:pt idx="1">
                          <c:v>MYC OE</c:v>
                        </c:pt>
                        <c:pt idx="2">
                          <c:v>NT</c:v>
                        </c:pt>
                        <c:pt idx="3">
                          <c:v>MYC OE</c:v>
                        </c:pt>
                      </c:lvl>
                      <c:lvl>
                        <c:pt idx="0">
                          <c:v>215</c:v>
                        </c:pt>
                        <c:pt idx="2">
                          <c:v>253</c:v>
                        </c:pt>
                      </c:lvl>
                    </c:multiLvlStrCache>
                  </c:multiLvl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ummary HPRT 2'!$P$53:$P$5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.0160956893289661</c:v>
                      </c:pt>
                      <c:pt idx="1">
                        <c:v>42.581165238078277</c:v>
                      </c:pt>
                      <c:pt idx="2">
                        <c:v>1.174592301254924</c:v>
                      </c:pt>
                      <c:pt idx="3">
                        <c:v>35.974667775873378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6343-C342-8D93-A160093C51D0}"/>
                  </c:ext>
                </c:extLst>
              </c15:ser>
            </c15:filteredBarSeries>
          </c:ext>
        </c:extLst>
      </c:barChart>
      <c:catAx>
        <c:axId val="285617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5617680"/>
        <c:crosses val="autoZero"/>
        <c:auto val="1"/>
        <c:lblAlgn val="ctr"/>
        <c:lblOffset val="100"/>
        <c:noMultiLvlLbl val="0"/>
      </c:catAx>
      <c:valAx>
        <c:axId val="285617680"/>
        <c:scaling>
          <c:logBase val="10"/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561712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27306188897521999"/>
          <c:y val="1.04453115972156E-2"/>
          <c:w val="0.48141490530305697"/>
          <c:h val="7.74171188779747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85902653324588"/>
          <c:y val="6.02716018720581E-2"/>
          <c:w val="0.77300992295154403"/>
          <c:h val="0.7107366502752166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Figure 2A MYC PGC '!$F$2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01F0-4A7C-B3DF-333C55C354A1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01F0-4A7C-B3DF-333C55C354A1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01F0-4A7C-B3DF-333C55C354A1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01F0-4A7C-B3DF-333C55C354A1}"/>
              </c:ext>
            </c:extLst>
          </c:dPt>
          <c:errBars>
            <c:errBarType val="plus"/>
            <c:errValType val="cust"/>
            <c:noEndCap val="0"/>
            <c:plus>
              <c:numRef>
                <c:f>'Figure 2A MYC PGC '!$G$16:$G$20</c:f>
                <c:numCache>
                  <c:formatCode>General</c:formatCode>
                  <c:ptCount val="4"/>
                  <c:pt idx="0">
                    <c:v>7.6198012323341613E-2</c:v>
                  </c:pt>
                  <c:pt idx="1">
                    <c:v>3.6279614168216043</c:v>
                  </c:pt>
                  <c:pt idx="2">
                    <c:v>0.49061686366969304</c:v>
                  </c:pt>
                  <c:pt idx="3">
                    <c:v>0.73788533699133574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igure 2A MYC PGC '!$B$10:$B$14</c:f>
              <c:strCache>
                <c:ptCount val="4"/>
                <c:pt idx="0">
                  <c:v>Met</c:v>
                </c:pt>
                <c:pt idx="1">
                  <c:v>Malon</c:v>
                </c:pt>
                <c:pt idx="2">
                  <c:v>UK5099</c:v>
                </c:pt>
                <c:pt idx="3">
                  <c:v>Tumor-like</c:v>
                </c:pt>
              </c:strCache>
              <c:extLst/>
            </c:strRef>
          </c:cat>
          <c:val>
            <c:numRef>
              <c:f>'Figure 2A MYC PGC '!$F$16:$F$20</c:f>
              <c:numCache>
                <c:formatCode>General</c:formatCode>
                <c:ptCount val="4"/>
                <c:pt idx="0">
                  <c:v>1.257270461345201</c:v>
                </c:pt>
                <c:pt idx="1">
                  <c:v>6.5795242672568603</c:v>
                </c:pt>
                <c:pt idx="2">
                  <c:v>2.3836882788959497</c:v>
                </c:pt>
                <c:pt idx="3">
                  <c:v>2.994146098945731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5-01F0-4A7C-B3DF-333C55C354A1}"/>
            </c:ext>
          </c:extLst>
        </c:ser>
        <c:ser>
          <c:idx val="0"/>
          <c:order val="1"/>
          <c:tx>
            <c:strRef>
              <c:f>'Figure 2A MYC PGC '!$I$2</c:f>
              <c:strCache>
                <c:ptCount val="1"/>
                <c:pt idx="0">
                  <c:v>PGC1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igure 2A MYC PGC '!$J$16:$J$20</c:f>
                <c:numCache>
                  <c:formatCode>General</c:formatCode>
                  <c:ptCount val="4"/>
                  <c:pt idx="0">
                    <c:v>6.4144049477268303E-2</c:v>
                  </c:pt>
                  <c:pt idx="1">
                    <c:v>3.6811125096510258E-2</c:v>
                  </c:pt>
                  <c:pt idx="2">
                    <c:v>0.54396415434331535</c:v>
                  </c:pt>
                  <c:pt idx="3">
                    <c:v>4.6879853461968025E-2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igure 2A MYC PGC '!$B$10:$B$14</c:f>
              <c:strCache>
                <c:ptCount val="4"/>
                <c:pt idx="0">
                  <c:v>Met</c:v>
                </c:pt>
                <c:pt idx="1">
                  <c:v>Malon</c:v>
                </c:pt>
                <c:pt idx="2">
                  <c:v>UK5099</c:v>
                </c:pt>
                <c:pt idx="3">
                  <c:v>Tumor-like</c:v>
                </c:pt>
              </c:strCache>
              <c:extLst/>
            </c:strRef>
          </c:cat>
          <c:val>
            <c:numRef>
              <c:f>'Figure 2A MYC PGC '!$I$16:$I$20</c:f>
              <c:numCache>
                <c:formatCode>General</c:formatCode>
                <c:ptCount val="4"/>
                <c:pt idx="0">
                  <c:v>0.30373236620013078</c:v>
                </c:pt>
                <c:pt idx="1">
                  <c:v>0.39351488005131091</c:v>
                </c:pt>
                <c:pt idx="2">
                  <c:v>0.76434966173740904</c:v>
                </c:pt>
                <c:pt idx="3">
                  <c:v>0.7074012690161234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6-01F0-4A7C-B3DF-333C55C354A1}"/>
            </c:ext>
          </c:extLst>
        </c:ser>
        <c:ser>
          <c:idx val="2"/>
          <c:order val="2"/>
          <c:tx>
            <c:v>MYC/PGC1A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igure 2A MYC PGC '!$D$16:$D$20</c:f>
                <c:numCache>
                  <c:formatCode>General</c:formatCode>
                  <c:ptCount val="4"/>
                  <c:pt idx="0">
                    <c:v>0.61716000000000004</c:v>
                  </c:pt>
                  <c:pt idx="1">
                    <c:v>0.80207091657884899</c:v>
                  </c:pt>
                  <c:pt idx="2">
                    <c:v>4.5964540854023888</c:v>
                  </c:pt>
                  <c:pt idx="3">
                    <c:v>1.6587713554030674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Lit>
              <c:ptCount val="3"/>
              <c:pt idx="0">
                <c:v>Met</c:v>
              </c:pt>
              <c:pt idx="1">
                <c:v>UK5099</c:v>
              </c:pt>
              <c:pt idx="2">
                <c:v>T-like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'Figure 2A MYC PGC '!$C$16:$C$20</c:f>
              <c:numCache>
                <c:formatCode>General</c:formatCode>
                <c:ptCount val="4"/>
                <c:pt idx="0">
                  <c:v>5.5221739999999997</c:v>
                </c:pt>
                <c:pt idx="1">
                  <c:v>4.960367892690134</c:v>
                </c:pt>
                <c:pt idx="2">
                  <c:v>15.662378598444645</c:v>
                </c:pt>
                <c:pt idx="3">
                  <c:v>4.115371779789530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7-01F0-4A7C-B3DF-333C55C354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85222128"/>
        <c:axId val="285222688"/>
      </c:barChart>
      <c:catAx>
        <c:axId val="285222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5222688"/>
        <c:crosses val="autoZero"/>
        <c:auto val="1"/>
        <c:lblAlgn val="ctr"/>
        <c:lblOffset val="100"/>
        <c:noMultiLvlLbl val="0"/>
      </c:catAx>
      <c:valAx>
        <c:axId val="285222688"/>
        <c:scaling>
          <c:logBase val="10"/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522212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98295556234011"/>
          <c:y val="3.6314128238299111E-2"/>
          <c:w val="0.77134134144672428"/>
          <c:h val="0.84965950909344168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Figure 2A MYC PGC '!$F$2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BEC1-4DA7-8354-F884AD11060C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BEC1-4DA7-8354-F884AD11060C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BEC1-4DA7-8354-F884AD11060C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BEC1-4DA7-8354-F884AD11060C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BEC1-4DA7-8354-F884AD11060C}"/>
              </c:ext>
            </c:extLst>
          </c:dPt>
          <c:errBars>
            <c:errBarType val="plus"/>
            <c:errValType val="cust"/>
            <c:noEndCap val="0"/>
            <c:plus>
              <c:numRef>
                <c:f>'Figure 2A MYC PGC '!$G$10:$G$14</c:f>
                <c:numCache>
                  <c:formatCode>General</c:formatCode>
                  <c:ptCount val="4"/>
                  <c:pt idx="0">
                    <c:v>0.68952000000000002</c:v>
                  </c:pt>
                  <c:pt idx="1">
                    <c:v>0.1006365357103714</c:v>
                  </c:pt>
                  <c:pt idx="2">
                    <c:v>0.35656191592600889</c:v>
                  </c:pt>
                  <c:pt idx="3">
                    <c:v>0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igure 2A MYC PGC '!$B$10:$B$14</c:f>
              <c:strCache>
                <c:ptCount val="4"/>
                <c:pt idx="0">
                  <c:v>Met</c:v>
                </c:pt>
                <c:pt idx="1">
                  <c:v>Malon</c:v>
                </c:pt>
                <c:pt idx="2">
                  <c:v>UK5099</c:v>
                </c:pt>
                <c:pt idx="3">
                  <c:v>Tumor-like</c:v>
                </c:pt>
              </c:strCache>
              <c:extLst/>
            </c:strRef>
          </c:cat>
          <c:val>
            <c:numRef>
              <c:f>'Figure 2A MYC PGC '!$F$10:$F$14</c:f>
              <c:numCache>
                <c:formatCode>General</c:formatCode>
                <c:ptCount val="4"/>
                <c:pt idx="0">
                  <c:v>2.3429592848394289</c:v>
                </c:pt>
                <c:pt idx="1">
                  <c:v>1.475908280817495</c:v>
                </c:pt>
                <c:pt idx="2">
                  <c:v>2.5422656603144262</c:v>
                </c:pt>
                <c:pt idx="3">
                  <c:v>1.588868693761756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5-BEC1-4DA7-8354-F884AD11060C}"/>
            </c:ext>
          </c:extLst>
        </c:ser>
        <c:ser>
          <c:idx val="0"/>
          <c:order val="1"/>
          <c:tx>
            <c:strRef>
              <c:f>'Figure 2A MYC PGC '!$I$2</c:f>
              <c:strCache>
                <c:ptCount val="1"/>
                <c:pt idx="0">
                  <c:v>PGC1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igure 2A MYC PGC '!$J$10:$J$14</c:f>
                <c:numCache>
                  <c:formatCode>General</c:formatCode>
                  <c:ptCount val="4"/>
                  <c:pt idx="0">
                    <c:v>0.12371</c:v>
                  </c:pt>
                  <c:pt idx="1">
                    <c:v>0.25704715757507979</c:v>
                  </c:pt>
                  <c:pt idx="2">
                    <c:v>2.9503756514734414E-2</c:v>
                  </c:pt>
                  <c:pt idx="3">
                    <c:v>7.6389494790608928E-2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igure 2A MYC PGC '!$B$10:$B$14</c:f>
              <c:strCache>
                <c:ptCount val="4"/>
                <c:pt idx="0">
                  <c:v>Met</c:v>
                </c:pt>
                <c:pt idx="1">
                  <c:v>Malon</c:v>
                </c:pt>
                <c:pt idx="2">
                  <c:v>UK5099</c:v>
                </c:pt>
                <c:pt idx="3">
                  <c:v>Tumor-like</c:v>
                </c:pt>
              </c:strCache>
              <c:extLst/>
            </c:strRef>
          </c:cat>
          <c:val>
            <c:numRef>
              <c:f>'Figure 2A MYC PGC '!$I$10:$I$14</c:f>
              <c:numCache>
                <c:formatCode>General</c:formatCode>
                <c:ptCount val="4"/>
                <c:pt idx="0">
                  <c:v>0.47150122686643592</c:v>
                </c:pt>
                <c:pt idx="1">
                  <c:v>1.100517834988564</c:v>
                </c:pt>
                <c:pt idx="2">
                  <c:v>0.55374770015851105</c:v>
                </c:pt>
                <c:pt idx="3">
                  <c:v>0.5074801121471640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6-BEC1-4DA7-8354-F884AD11060C}"/>
            </c:ext>
          </c:extLst>
        </c:ser>
        <c:ser>
          <c:idx val="2"/>
          <c:order val="2"/>
          <c:tx>
            <c:v>MYC/PGC1A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igure 2A MYC PGC '!$D$4:$D$8</c:f>
                <c:numCache>
                  <c:formatCode>General</c:formatCode>
                  <c:ptCount val="4"/>
                  <c:pt idx="0">
                    <c:v>0.17849899999999999</c:v>
                  </c:pt>
                  <c:pt idx="1">
                    <c:v>0.10000674386854033</c:v>
                  </c:pt>
                  <c:pt idx="2">
                    <c:v>0.46900252073363807</c:v>
                  </c:pt>
                  <c:pt idx="3">
                    <c:v>0.32455978432319388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Lit>
              <c:ptCount val="4"/>
              <c:pt idx="0">
                <c:v>Met</c:v>
              </c:pt>
              <c:pt idx="1">
                <c:v>Malon</c:v>
              </c:pt>
              <c:pt idx="2">
                <c:v>UK5099</c:v>
              </c:pt>
              <c:pt idx="3">
                <c:v>Tumor-like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'Figure 2A MYC PGC '!$C$10:$C$14</c:f>
              <c:numCache>
                <c:formatCode>General</c:formatCode>
                <c:ptCount val="4"/>
                <c:pt idx="0">
                  <c:v>2.98875</c:v>
                </c:pt>
                <c:pt idx="1">
                  <c:v>1.6294494174159724</c:v>
                </c:pt>
                <c:pt idx="2">
                  <c:v>4.5419712159580863</c:v>
                </c:pt>
                <c:pt idx="3">
                  <c:v>3.37372265865650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7-BEC1-4DA7-8354-F884AD1106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85226048"/>
        <c:axId val="285226608"/>
      </c:barChart>
      <c:catAx>
        <c:axId val="285226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5226608"/>
        <c:crosses val="autoZero"/>
        <c:auto val="1"/>
        <c:lblAlgn val="ctr"/>
        <c:lblOffset val="100"/>
        <c:noMultiLvlLbl val="0"/>
      </c:catAx>
      <c:valAx>
        <c:axId val="285226608"/>
        <c:scaling>
          <c:logBase val="10"/>
          <c:orientation val="minMax"/>
        </c:scaling>
        <c:delete val="0"/>
        <c:axPos val="l"/>
        <c:numFmt formatCode="General" sourceLinked="1"/>
        <c:majorTickMark val="in"/>
        <c:minorTickMark val="none"/>
        <c:tickLblPos val="low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52260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792100480291797"/>
          <c:y val="3.5154805709393527E-2"/>
          <c:w val="0.77391101589938649"/>
          <c:h val="0.70587014075762755"/>
        </c:manualLayout>
      </c:layout>
      <c:barChart>
        <c:barDir val="col"/>
        <c:grouping val="clustered"/>
        <c:varyColors val="0"/>
        <c:ser>
          <c:idx val="1"/>
          <c:order val="0"/>
          <c:tx>
            <c:v>MYC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709-4C78-84B1-D8457E30BEE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2709-4C78-84B1-D8457E30BEE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2709-4C78-84B1-D8457E30BEE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2709-4C78-84B1-D8457E30BEE7}"/>
              </c:ext>
            </c:extLst>
          </c:dPt>
          <c:errBars>
            <c:errBarType val="plus"/>
            <c:errValType val="cust"/>
            <c:noEndCap val="0"/>
            <c:plus>
              <c:numRef>
                <c:f>'Figure 2A MYC PGC '!$G$4:$G$8</c:f>
                <c:numCache>
                  <c:formatCode>General</c:formatCode>
                  <c:ptCount val="4"/>
                  <c:pt idx="0">
                    <c:v>1.2301740000000001</c:v>
                  </c:pt>
                  <c:pt idx="1">
                    <c:v>2.693512763050256</c:v>
                  </c:pt>
                  <c:pt idx="2">
                    <c:v>0.14822524530519129</c:v>
                  </c:pt>
                  <c:pt idx="3">
                    <c:v>9.9452518206867513E-2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igure 2A MYC PGC '!$B$10:$B$14</c:f>
              <c:strCache>
                <c:ptCount val="4"/>
                <c:pt idx="0">
                  <c:v>Met</c:v>
                </c:pt>
                <c:pt idx="1">
                  <c:v>Malon</c:v>
                </c:pt>
                <c:pt idx="2">
                  <c:v>UK5099</c:v>
                </c:pt>
                <c:pt idx="3">
                  <c:v>Tumor-like</c:v>
                </c:pt>
              </c:strCache>
              <c:extLst/>
            </c:strRef>
          </c:cat>
          <c:val>
            <c:numRef>
              <c:f>'Figure 2A MYC PGC '!$F$4:$F$8</c:f>
              <c:numCache>
                <c:formatCode>General</c:formatCode>
                <c:ptCount val="4"/>
                <c:pt idx="0">
                  <c:v>3.6309165192367852</c:v>
                </c:pt>
                <c:pt idx="1">
                  <c:v>5.5463042998328147</c:v>
                </c:pt>
                <c:pt idx="2">
                  <c:v>2.8490641983464684</c:v>
                </c:pt>
                <c:pt idx="3">
                  <c:v>2.553624025758320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5-2709-4C78-84B1-D8457E30BEE7}"/>
            </c:ext>
          </c:extLst>
        </c:ser>
        <c:ser>
          <c:idx val="0"/>
          <c:order val="1"/>
          <c:tx>
            <c:strRef>
              <c:f>'Figure 2A MYC PGC '!$I$2</c:f>
              <c:strCache>
                <c:ptCount val="1"/>
                <c:pt idx="0">
                  <c:v>PGC1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igure 2A MYC PGC '!$J$4:$J$8</c:f>
                <c:numCache>
                  <c:formatCode>General</c:formatCode>
                  <c:ptCount val="4"/>
                  <c:pt idx="0">
                    <c:v>7.8539999999999999E-2</c:v>
                  </c:pt>
                  <c:pt idx="1">
                    <c:v>1.0498959890905744</c:v>
                  </c:pt>
                  <c:pt idx="2">
                    <c:v>0.22000287785187639</c:v>
                  </c:pt>
                  <c:pt idx="3">
                    <c:v>0.17396306879540877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igure 2A MYC PGC '!$B$10:$B$14</c:f>
              <c:strCache>
                <c:ptCount val="4"/>
                <c:pt idx="0">
                  <c:v>Met</c:v>
                </c:pt>
                <c:pt idx="1">
                  <c:v>Malon</c:v>
                </c:pt>
                <c:pt idx="2">
                  <c:v>UK5099</c:v>
                </c:pt>
                <c:pt idx="3">
                  <c:v>Tumor-like</c:v>
                </c:pt>
              </c:strCache>
              <c:extLst/>
            </c:strRef>
          </c:cat>
          <c:val>
            <c:numRef>
              <c:f>'Figure 2A MYC PGC '!$I$4:$I$8</c:f>
              <c:numCache>
                <c:formatCode>General</c:formatCode>
                <c:ptCount val="4"/>
                <c:pt idx="0">
                  <c:v>0.78422127292108423</c:v>
                </c:pt>
                <c:pt idx="1">
                  <c:v>1.0350403274384301</c:v>
                </c:pt>
                <c:pt idx="2">
                  <c:v>1.1865983511226994</c:v>
                </c:pt>
                <c:pt idx="3">
                  <c:v>0.7585670087328925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6-2709-4C78-84B1-D8457E30BEE7}"/>
            </c:ext>
          </c:extLst>
        </c:ser>
        <c:ser>
          <c:idx val="2"/>
          <c:order val="2"/>
          <c:tx>
            <c:v>MYC/PGC1A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igure 2A MYC PGC '!$D$4:$D$8</c:f>
                <c:numCache>
                  <c:formatCode>General</c:formatCode>
                  <c:ptCount val="4"/>
                  <c:pt idx="0">
                    <c:v>0.17849899999999999</c:v>
                  </c:pt>
                  <c:pt idx="1">
                    <c:v>0.10000674386854033</c:v>
                  </c:pt>
                  <c:pt idx="2">
                    <c:v>0.46900252073363807</c:v>
                  </c:pt>
                  <c:pt idx="3">
                    <c:v>0.32455978432319388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Lit>
              <c:ptCount val="3"/>
              <c:pt idx="0">
                <c:v>Met</c:v>
              </c:pt>
              <c:pt idx="1">
                <c:v>UK5099</c:v>
              </c:pt>
              <c:pt idx="2">
                <c:v>T-like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'Figure 2A MYC PGC '!$C$4:$C$8</c:f>
              <c:numCache>
                <c:formatCode>General</c:formatCode>
                <c:ptCount val="4"/>
                <c:pt idx="0">
                  <c:v>3.2116699999999998</c:v>
                </c:pt>
                <c:pt idx="1">
                  <c:v>2.8779071854887452</c:v>
                </c:pt>
                <c:pt idx="2">
                  <c:v>3.0199982111550066</c:v>
                </c:pt>
                <c:pt idx="3">
                  <c:v>4.381762110861335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7-2709-4C78-84B1-D8457E30BE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85229968"/>
        <c:axId val="285230528"/>
      </c:barChart>
      <c:catAx>
        <c:axId val="285229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5230528"/>
        <c:crosses val="autoZero"/>
        <c:auto val="1"/>
        <c:lblAlgn val="ctr"/>
        <c:lblOffset val="100"/>
        <c:noMultiLvlLbl val="0"/>
      </c:catAx>
      <c:valAx>
        <c:axId val="285230528"/>
        <c:scaling>
          <c:logBase val="10"/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522996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8223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13" Type="http://schemas.openxmlformats.org/officeDocument/2006/relationships/image" Target="../media/image5.jpeg"/><Relationship Id="rId3" Type="http://schemas.openxmlformats.org/officeDocument/2006/relationships/chart" Target="../charts/chart1.xml"/><Relationship Id="rId7" Type="http://schemas.microsoft.com/office/2007/relationships/hdphoto" Target="../media/hdphoto2.wdp"/><Relationship Id="rId12" Type="http://schemas.openxmlformats.org/officeDocument/2006/relationships/image" Target="../media/image4.jpeg"/><Relationship Id="rId17" Type="http://schemas.openxmlformats.org/officeDocument/2006/relationships/image" Target="../media/image9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11" Type="http://schemas.openxmlformats.org/officeDocument/2006/relationships/image" Target="../media/image3.jpeg"/><Relationship Id="rId5" Type="http://schemas.microsoft.com/office/2007/relationships/hdphoto" Target="../media/hdphoto1.wdp"/><Relationship Id="rId15" Type="http://schemas.openxmlformats.org/officeDocument/2006/relationships/image" Target="../media/image7.jpeg"/><Relationship Id="rId10" Type="http://schemas.openxmlformats.org/officeDocument/2006/relationships/chart" Target="../charts/chart4.xml"/><Relationship Id="rId4" Type="http://schemas.openxmlformats.org/officeDocument/2006/relationships/image" Target="../media/image1.png"/><Relationship Id="rId9" Type="http://schemas.openxmlformats.org/officeDocument/2006/relationships/chart" Target="../charts/chart3.xml"/><Relationship Id="rId1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TextBox 107">
            <a:extLst>
              <a:ext uri="{FF2B5EF4-FFF2-40B4-BE49-F238E27FC236}">
                <a16:creationId xmlns:a16="http://schemas.microsoft.com/office/drawing/2014/main" id="{3F7E0976-1B94-FF42-827E-185B4772F834}"/>
              </a:ext>
            </a:extLst>
          </p:cNvPr>
          <p:cNvSpPr txBox="1"/>
          <p:nvPr/>
        </p:nvSpPr>
        <p:spPr>
          <a:xfrm>
            <a:off x="24735" y="406370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688068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Figure S10, related to Figure 6</a:t>
            </a:r>
          </a:p>
          <a:p>
            <a:pPr algn="just"/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n elevated ratio between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YC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d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GC1A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expression is linked to EMT induction by starvation and </a:t>
            </a:r>
            <a:r>
              <a:rPr lang="en-US" sz="1000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seudostarvation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triggers.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here indicated, cells were treated with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acrophage-conditioned medium (MCM) or etomoxir 20 </a:t>
            </a:r>
            <a:r>
              <a:rPr lang="en-US" sz="1000" dirty="0">
                <a:latin typeface="Symbol" charset="2"/>
                <a:ea typeface="Arial" charset="0"/>
                <a:cs typeface="Symbol" charset="2"/>
              </a:rPr>
              <a:t>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 (Eto) for 48h.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ells transduced with lentiviral constructs were pretreated with doxycycline for 48h before treatments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MY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overexpression (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MY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OE) promotes EMT-like phenotype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Right panels:  representative images of parental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MY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-overexpressing PDAC-215 cells. Left panel: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MY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VI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,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ZEB1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expression.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Expression of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MY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GC1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MYC/PGC1A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ratio in PDAC-215 (left panel), PDAC-253 (middle panel) and PDAC-354 (right panel) after mitochondrial energy deprivation during 48h (n=3)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MY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GC1A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PARGC1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expression in single PDAC-002 cells shown in Figure 2C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MYC and PGC-1α expression measured by Western Blot following 48h treatment with MCM</a:t>
            </a:r>
            <a:r>
              <a:rPr lang="en-US" sz="1000">
                <a:latin typeface="Arial" charset="0"/>
                <a:ea typeface="Arial" charset="0"/>
                <a:cs typeface="Arial" charset="0"/>
              </a:rPr>
              <a:t>, etomoxir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, or the PPAR-δ agonist L-165 (5 µM). Vinculin was used as loading control. All data are represented as mean ± SEM. * p&lt;0.05, ** p&lt;0.01, *** p&lt;0.001 vs NT (A) or control (B, set as 1) cells.</a:t>
            </a:r>
            <a:endParaRPr lang="en-US" sz="1000" dirty="0">
              <a:highlight>
                <a:srgbClr val="FFFF00"/>
              </a:highlight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570A6E6-DC5F-FB4F-A7EE-7D210F85EF80}"/>
              </a:ext>
            </a:extLst>
          </p:cNvPr>
          <p:cNvSpPr txBox="1"/>
          <p:nvPr/>
        </p:nvSpPr>
        <p:spPr>
          <a:xfrm>
            <a:off x="24735" y="21604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3" name="Group 72"/>
          <p:cNvGrpSpPr>
            <a:grpSpLocks noChangeAspect="1"/>
          </p:cNvGrpSpPr>
          <p:nvPr/>
        </p:nvGrpSpPr>
        <p:grpSpPr>
          <a:xfrm>
            <a:off x="3436443" y="2202448"/>
            <a:ext cx="2626245" cy="1868599"/>
            <a:chOff x="2530764" y="3578797"/>
            <a:chExt cx="3396176" cy="2772539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121C966-C391-EA41-8982-B7CD3A9CDACC}"/>
                </a:ext>
              </a:extLst>
            </p:cNvPr>
            <p:cNvSpPr txBox="1"/>
            <p:nvPr/>
          </p:nvSpPr>
          <p:spPr>
            <a:xfrm rot="16200000">
              <a:off x="2022132" y="4490053"/>
              <a:ext cx="1417376" cy="400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</a:t>
              </a:r>
            </a:p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Fold change vs NT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75" name="Chart 74">
              <a:extLst>
                <a:ext uri="{FF2B5EF4-FFF2-40B4-BE49-F238E27FC236}">
                  <a16:creationId xmlns:a16="http://schemas.microsoft.com/office/drawing/2014/main" id="{A8578386-DB1C-764A-93F9-98CC5A967DE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989680" y="3578797"/>
            <a:ext cx="2836628" cy="277253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2A25FBA9-EA07-5A48-8A6A-4E3D26E80358}"/>
                </a:ext>
              </a:extLst>
            </p:cNvPr>
            <p:cNvSpPr txBox="1"/>
            <p:nvPr/>
          </p:nvSpPr>
          <p:spPr>
            <a:xfrm>
              <a:off x="4141988" y="4003980"/>
              <a:ext cx="477609" cy="40100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97309564-802D-1B4C-828F-46163133C125}"/>
                </a:ext>
              </a:extLst>
            </p:cNvPr>
            <p:cNvSpPr txBox="1"/>
            <p:nvPr/>
          </p:nvSpPr>
          <p:spPr>
            <a:xfrm>
              <a:off x="4290790" y="4374909"/>
              <a:ext cx="477609" cy="40100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B3F66F86-B8F0-5F4B-A001-307D357E1AEE}"/>
                </a:ext>
              </a:extLst>
            </p:cNvPr>
            <p:cNvSpPr txBox="1"/>
            <p:nvPr/>
          </p:nvSpPr>
          <p:spPr>
            <a:xfrm>
              <a:off x="4004095" y="4335702"/>
              <a:ext cx="477609" cy="40100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3EEE2A91-F4F4-374B-A037-70B9DA824537}"/>
                </a:ext>
              </a:extLst>
            </p:cNvPr>
            <p:cNvSpPr txBox="1"/>
            <p:nvPr/>
          </p:nvSpPr>
          <p:spPr>
            <a:xfrm>
              <a:off x="5153218" y="4394806"/>
              <a:ext cx="477608" cy="40100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7A788EBF-5DA7-054E-9AAD-0110A76FF4C8}"/>
                </a:ext>
              </a:extLst>
            </p:cNvPr>
            <p:cNvSpPr txBox="1"/>
            <p:nvPr/>
          </p:nvSpPr>
          <p:spPr>
            <a:xfrm>
              <a:off x="5305625" y="4261375"/>
              <a:ext cx="477608" cy="40100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3D77145F-D461-114B-94E1-3F963754AD3A}"/>
                </a:ext>
              </a:extLst>
            </p:cNvPr>
            <p:cNvSpPr txBox="1"/>
            <p:nvPr/>
          </p:nvSpPr>
          <p:spPr>
            <a:xfrm>
              <a:off x="5449332" y="4236233"/>
              <a:ext cx="477608" cy="40100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Straight Connector 64">
              <a:extLst>
                <a:ext uri="{FF2B5EF4-FFF2-40B4-BE49-F238E27FC236}">
                  <a16:creationId xmlns:a16="http://schemas.microsoft.com/office/drawing/2014/main" id="{6062ABFC-F1FF-5844-8D8E-7CDBA8074201}"/>
                </a:ext>
              </a:extLst>
            </p:cNvPr>
            <p:cNvCxnSpPr/>
            <p:nvPr/>
          </p:nvCxnSpPr>
          <p:spPr>
            <a:xfrm>
              <a:off x="4797619" y="6110195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67">
              <a:extLst>
                <a:ext uri="{FF2B5EF4-FFF2-40B4-BE49-F238E27FC236}">
                  <a16:creationId xmlns:a16="http://schemas.microsoft.com/office/drawing/2014/main" id="{A7D2358C-8237-344F-AC84-AF4F76C369F1}"/>
                </a:ext>
              </a:extLst>
            </p:cNvPr>
            <p:cNvCxnSpPr/>
            <p:nvPr/>
          </p:nvCxnSpPr>
          <p:spPr>
            <a:xfrm>
              <a:off x="3606267" y="6110195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upo 1">
            <a:extLst>
              <a:ext uri="{FF2B5EF4-FFF2-40B4-BE49-F238E27FC236}">
                <a16:creationId xmlns:a16="http://schemas.microsoft.com/office/drawing/2014/main" id="{46021CD5-3792-57A0-BB50-447825968EA1}"/>
              </a:ext>
            </a:extLst>
          </p:cNvPr>
          <p:cNvGrpSpPr/>
          <p:nvPr/>
        </p:nvGrpSpPr>
        <p:grpSpPr>
          <a:xfrm>
            <a:off x="302848" y="2488539"/>
            <a:ext cx="2891771" cy="1063262"/>
            <a:chOff x="265524" y="3683620"/>
            <a:chExt cx="2891771" cy="1063262"/>
          </a:xfrm>
        </p:grpSpPr>
        <p:grpSp>
          <p:nvGrpSpPr>
            <p:cNvPr id="84" name="Group 83"/>
            <p:cNvGrpSpPr>
              <a:grpSpLocks noChangeAspect="1"/>
            </p:cNvGrpSpPr>
            <p:nvPr/>
          </p:nvGrpSpPr>
          <p:grpSpPr>
            <a:xfrm>
              <a:off x="265524" y="3683620"/>
              <a:ext cx="2891771" cy="1056433"/>
              <a:chOff x="125229" y="2803428"/>
              <a:chExt cx="3407648" cy="1244895"/>
            </a:xfrm>
          </p:grpSpPr>
          <p:pic>
            <p:nvPicPr>
              <p:cNvPr id="85" name="Picture 26">
                <a:extLst>
                  <a:ext uri="{FF2B5EF4-FFF2-40B4-BE49-F238E27FC236}">
                    <a16:creationId xmlns:a16="http://schemas.microsoft.com/office/drawing/2014/main" id="{285EDE81-CC09-8E4B-961F-B842D78D5E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50000"/>
                        </a14:imgEffect>
                        <a14:imgEffect>
                          <a14:saturation sat="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1873136" y="2804941"/>
                <a:ext cx="1659741" cy="1240036"/>
              </a:xfrm>
              <a:prstGeom prst="rect">
                <a:avLst/>
              </a:prstGeom>
            </p:spPr>
          </p:pic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3F30B503-A6B1-F24E-8F25-BAF970C1BCCB}"/>
                  </a:ext>
                </a:extLst>
              </p:cNvPr>
              <p:cNvSpPr txBox="1"/>
              <p:nvPr/>
            </p:nvSpPr>
            <p:spPr>
              <a:xfrm>
                <a:off x="807251" y="3585123"/>
                <a:ext cx="18473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dirty="0"/>
              </a:p>
            </p:txBody>
          </p:sp>
          <p:pic>
            <p:nvPicPr>
              <p:cNvPr id="87" name="Picture 2" descr="M:\Barts\Exps\Fotos\shMYC EMT 19111\215\215 NT dox MCM.jpg">
                <a:extLst>
                  <a:ext uri="{FF2B5EF4-FFF2-40B4-BE49-F238E27FC236}">
                    <a16:creationId xmlns:a16="http://schemas.microsoft.com/office/drawing/2014/main" id="{19F25F72-D7E9-D148-A798-7F7A612ACBE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069" t="28492" r="25014" b="23978"/>
              <a:stretch/>
            </p:blipFill>
            <p:spPr bwMode="auto">
              <a:xfrm>
                <a:off x="153786" y="2803428"/>
                <a:ext cx="1660146" cy="124489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C1A317AE-F689-6E45-959F-C3505F41DD0A}"/>
                  </a:ext>
                </a:extLst>
              </p:cNvPr>
              <p:cNvSpPr txBox="1"/>
              <p:nvPr/>
            </p:nvSpPr>
            <p:spPr>
              <a:xfrm>
                <a:off x="125229" y="3762130"/>
                <a:ext cx="6415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C1A317AE-F689-6E45-959F-C3505F41DD0A}"/>
                </a:ext>
              </a:extLst>
            </p:cNvPr>
            <p:cNvSpPr txBox="1"/>
            <p:nvPr/>
          </p:nvSpPr>
          <p:spPr>
            <a:xfrm>
              <a:off x="1721763" y="4500661"/>
              <a:ext cx="6905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OE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upo 5"/>
          <p:cNvGrpSpPr>
            <a:grpSpLocks noChangeAspect="1"/>
          </p:cNvGrpSpPr>
          <p:nvPr/>
        </p:nvGrpSpPr>
        <p:grpSpPr>
          <a:xfrm>
            <a:off x="171917" y="4390800"/>
            <a:ext cx="5913405" cy="2286393"/>
            <a:chOff x="-188358" y="6476005"/>
            <a:chExt cx="7110239" cy="2749142"/>
          </a:xfrm>
        </p:grpSpPr>
        <p:graphicFrame>
          <p:nvGraphicFramePr>
            <p:cNvPr id="9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12053650"/>
                </p:ext>
              </p:extLst>
            </p:nvPr>
          </p:nvGraphicFramePr>
          <p:xfrm>
            <a:off x="4529749" y="6669757"/>
            <a:ext cx="2392132" cy="25285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96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54682785"/>
                </p:ext>
              </p:extLst>
            </p:nvPr>
          </p:nvGraphicFramePr>
          <p:xfrm>
            <a:off x="2288322" y="6680525"/>
            <a:ext cx="2374675" cy="25446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90" name="Chart 2"/>
            <p:cNvGraphicFramePr>
              <a:graphicFrameLocks/>
            </p:cNvGraphicFramePr>
            <p:nvPr/>
          </p:nvGraphicFramePr>
          <p:xfrm>
            <a:off x="40668" y="6692459"/>
            <a:ext cx="2401665" cy="25288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94" name="19 CuadroTexto">
              <a:extLst>
                <a:ext uri="{FF2B5EF4-FFF2-40B4-BE49-F238E27FC236}">
                  <a16:creationId xmlns:a16="http://schemas.microsoft.com/office/drawing/2014/main" id="{68544438-4F81-C047-9A4D-37F4D3A83D87}"/>
                </a:ext>
              </a:extLst>
            </p:cNvPr>
            <p:cNvSpPr txBox="1"/>
            <p:nvPr/>
          </p:nvSpPr>
          <p:spPr>
            <a:xfrm>
              <a:off x="3643106" y="8243818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-253</a:t>
              </a:r>
            </a:p>
          </p:txBody>
        </p:sp>
        <p:sp>
          <p:nvSpPr>
            <p:cNvPr id="91" name="54 CuadroTexto">
              <a:extLst>
                <a:ext uri="{FF2B5EF4-FFF2-40B4-BE49-F238E27FC236}">
                  <a16:creationId xmlns:a16="http://schemas.microsoft.com/office/drawing/2014/main" id="{C0F21499-4445-CC4D-8494-8E2A9D8DE2CA}"/>
                </a:ext>
              </a:extLst>
            </p:cNvPr>
            <p:cNvSpPr txBox="1"/>
            <p:nvPr/>
          </p:nvSpPr>
          <p:spPr>
            <a:xfrm>
              <a:off x="1412929" y="8243818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-215</a:t>
              </a:r>
            </a:p>
          </p:txBody>
        </p:sp>
        <p:sp>
          <p:nvSpPr>
            <p:cNvPr id="111" name="TextBox 22">
              <a:extLst>
                <a:ext uri="{FF2B5EF4-FFF2-40B4-BE49-F238E27FC236}">
                  <a16:creationId xmlns:a16="http://schemas.microsoft.com/office/drawing/2014/main" id="{703884A1-819F-834A-8942-721423889CC3}"/>
                </a:ext>
              </a:extLst>
            </p:cNvPr>
            <p:cNvSpPr txBox="1"/>
            <p:nvPr/>
          </p:nvSpPr>
          <p:spPr>
            <a:xfrm rot="16200000">
              <a:off x="-1193922" y="7599136"/>
              <a:ext cx="22573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(fold change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48">
              <a:extLst>
                <a:ext uri="{FF2B5EF4-FFF2-40B4-BE49-F238E27FC236}">
                  <a16:creationId xmlns:a16="http://schemas.microsoft.com/office/drawing/2014/main" id="{91FECDBD-BBE3-AD43-9D57-EB10E1F5457B}"/>
                </a:ext>
              </a:extLst>
            </p:cNvPr>
            <p:cNvSpPr txBox="1"/>
            <p:nvPr/>
          </p:nvSpPr>
          <p:spPr>
            <a:xfrm>
              <a:off x="1097659" y="7049341"/>
              <a:ext cx="341542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38">
              <a:extLst>
                <a:ext uri="{FF2B5EF4-FFF2-40B4-BE49-F238E27FC236}">
                  <a16:creationId xmlns:a16="http://schemas.microsoft.com/office/drawing/2014/main" id="{610D6BDE-73B0-CD4D-AA92-76B5907B9477}"/>
                </a:ext>
              </a:extLst>
            </p:cNvPr>
            <p:cNvSpPr txBox="1"/>
            <p:nvPr/>
          </p:nvSpPr>
          <p:spPr>
            <a:xfrm>
              <a:off x="662855" y="6999878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5">
              <a:extLst>
                <a:ext uri="{FF2B5EF4-FFF2-40B4-BE49-F238E27FC236}">
                  <a16:creationId xmlns:a16="http://schemas.microsoft.com/office/drawing/2014/main" id="{96EB2FAC-5DD5-7B4E-9ED0-83D9CF27000D}"/>
                </a:ext>
              </a:extLst>
            </p:cNvPr>
            <p:cNvSpPr txBox="1"/>
            <p:nvPr/>
          </p:nvSpPr>
          <p:spPr>
            <a:xfrm>
              <a:off x="2021707" y="6870741"/>
              <a:ext cx="341542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6">
              <a:extLst>
                <a:ext uri="{FF2B5EF4-FFF2-40B4-BE49-F238E27FC236}">
                  <a16:creationId xmlns:a16="http://schemas.microsoft.com/office/drawing/2014/main" id="{ECB0C0C1-10FF-9E4A-B7E9-647AA3DB4559}"/>
                </a:ext>
              </a:extLst>
            </p:cNvPr>
            <p:cNvSpPr txBox="1"/>
            <p:nvPr/>
          </p:nvSpPr>
          <p:spPr>
            <a:xfrm>
              <a:off x="1565339" y="6999853"/>
              <a:ext cx="341542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5">
              <a:extLst>
                <a:ext uri="{FF2B5EF4-FFF2-40B4-BE49-F238E27FC236}">
                  <a16:creationId xmlns:a16="http://schemas.microsoft.com/office/drawing/2014/main" id="{FCF6C145-6F07-D848-8EE5-53232AD92D14}"/>
                </a:ext>
              </a:extLst>
            </p:cNvPr>
            <p:cNvSpPr txBox="1"/>
            <p:nvPr/>
          </p:nvSpPr>
          <p:spPr>
            <a:xfrm>
              <a:off x="4243841" y="6948420"/>
              <a:ext cx="341542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38">
              <a:extLst>
                <a:ext uri="{FF2B5EF4-FFF2-40B4-BE49-F238E27FC236}">
                  <a16:creationId xmlns:a16="http://schemas.microsoft.com/office/drawing/2014/main" id="{58EB0F3B-7D31-F747-9CCB-E41FA97EFEF5}"/>
                </a:ext>
              </a:extLst>
            </p:cNvPr>
            <p:cNvSpPr txBox="1"/>
            <p:nvPr/>
          </p:nvSpPr>
          <p:spPr>
            <a:xfrm>
              <a:off x="427675" y="6862914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38">
              <a:extLst>
                <a:ext uri="{FF2B5EF4-FFF2-40B4-BE49-F238E27FC236}">
                  <a16:creationId xmlns:a16="http://schemas.microsoft.com/office/drawing/2014/main" id="{9E5C56A8-D086-A24E-BD32-C802740617D8}"/>
                </a:ext>
              </a:extLst>
            </p:cNvPr>
            <p:cNvSpPr txBox="1"/>
            <p:nvPr/>
          </p:nvSpPr>
          <p:spPr>
            <a:xfrm>
              <a:off x="894513" y="6677468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6">
              <a:extLst>
                <a:ext uri="{FF2B5EF4-FFF2-40B4-BE49-F238E27FC236}">
                  <a16:creationId xmlns:a16="http://schemas.microsoft.com/office/drawing/2014/main" id="{5A325D8D-7095-D443-B387-84FA0FF92C27}"/>
                </a:ext>
              </a:extLst>
            </p:cNvPr>
            <p:cNvSpPr txBox="1"/>
            <p:nvPr/>
          </p:nvSpPr>
          <p:spPr>
            <a:xfrm>
              <a:off x="1336241" y="7060127"/>
              <a:ext cx="341542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6">
              <a:extLst>
                <a:ext uri="{FF2B5EF4-FFF2-40B4-BE49-F238E27FC236}">
                  <a16:creationId xmlns:a16="http://schemas.microsoft.com/office/drawing/2014/main" id="{B1AEF29F-6945-6D48-AF15-AB66A5A7CA1F}"/>
                </a:ext>
              </a:extLst>
            </p:cNvPr>
            <p:cNvSpPr txBox="1"/>
            <p:nvPr/>
          </p:nvSpPr>
          <p:spPr>
            <a:xfrm>
              <a:off x="1791091" y="7096171"/>
              <a:ext cx="341542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38">
              <a:extLst>
                <a:ext uri="{FF2B5EF4-FFF2-40B4-BE49-F238E27FC236}">
                  <a16:creationId xmlns:a16="http://schemas.microsoft.com/office/drawing/2014/main" id="{05E15203-3399-1C41-80E2-D0629D95E644}"/>
                </a:ext>
              </a:extLst>
            </p:cNvPr>
            <p:cNvSpPr txBox="1"/>
            <p:nvPr/>
          </p:nvSpPr>
          <p:spPr>
            <a:xfrm>
              <a:off x="4159119" y="7845317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5">
              <a:extLst>
                <a:ext uri="{FF2B5EF4-FFF2-40B4-BE49-F238E27FC236}">
                  <a16:creationId xmlns:a16="http://schemas.microsoft.com/office/drawing/2014/main" id="{7A75CF6A-5356-544A-BC94-934A6F99C65D}"/>
                </a:ext>
              </a:extLst>
            </p:cNvPr>
            <p:cNvSpPr txBox="1"/>
            <p:nvPr/>
          </p:nvSpPr>
          <p:spPr>
            <a:xfrm>
              <a:off x="4007817" y="7271477"/>
              <a:ext cx="341542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162 CuadroTexto">
              <a:extLst>
                <a:ext uri="{FF2B5EF4-FFF2-40B4-BE49-F238E27FC236}">
                  <a16:creationId xmlns:a16="http://schemas.microsoft.com/office/drawing/2014/main" id="{F66DFA19-405B-1D4C-9B6E-A04BB48BE61B}"/>
                </a:ext>
              </a:extLst>
            </p:cNvPr>
            <p:cNvSpPr txBox="1"/>
            <p:nvPr/>
          </p:nvSpPr>
          <p:spPr>
            <a:xfrm>
              <a:off x="5958419" y="8243818"/>
              <a:ext cx="8034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-354</a:t>
              </a:r>
            </a:p>
          </p:txBody>
        </p:sp>
        <p:sp>
          <p:nvSpPr>
            <p:cNvPr id="119" name="TextBox 38">
              <a:extLst>
                <a:ext uri="{FF2B5EF4-FFF2-40B4-BE49-F238E27FC236}">
                  <a16:creationId xmlns:a16="http://schemas.microsoft.com/office/drawing/2014/main" id="{2114A4C4-06EA-5746-9AFF-6E218E158F08}"/>
                </a:ext>
              </a:extLst>
            </p:cNvPr>
            <p:cNvSpPr txBox="1"/>
            <p:nvPr/>
          </p:nvSpPr>
          <p:spPr>
            <a:xfrm>
              <a:off x="2904910" y="7021296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38">
              <a:extLst>
                <a:ext uri="{FF2B5EF4-FFF2-40B4-BE49-F238E27FC236}">
                  <a16:creationId xmlns:a16="http://schemas.microsoft.com/office/drawing/2014/main" id="{77285166-8759-C440-84D3-2334DE0BF9BA}"/>
                </a:ext>
              </a:extLst>
            </p:cNvPr>
            <p:cNvSpPr txBox="1"/>
            <p:nvPr/>
          </p:nvSpPr>
          <p:spPr>
            <a:xfrm>
              <a:off x="2784077" y="7876611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38">
              <a:extLst>
                <a:ext uri="{FF2B5EF4-FFF2-40B4-BE49-F238E27FC236}">
                  <a16:creationId xmlns:a16="http://schemas.microsoft.com/office/drawing/2014/main" id="{4A902B98-84E9-E644-A0C4-1ABA16AD3421}"/>
                </a:ext>
              </a:extLst>
            </p:cNvPr>
            <p:cNvSpPr txBox="1"/>
            <p:nvPr/>
          </p:nvSpPr>
          <p:spPr>
            <a:xfrm>
              <a:off x="2676036" y="7038118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Grupo 4"/>
            <p:cNvGrpSpPr/>
            <p:nvPr/>
          </p:nvGrpSpPr>
          <p:grpSpPr>
            <a:xfrm>
              <a:off x="3681936" y="6476005"/>
              <a:ext cx="887940" cy="230832"/>
              <a:chOff x="1885487" y="6466272"/>
              <a:chExt cx="887940" cy="230832"/>
            </a:xfrm>
          </p:grpSpPr>
          <p:sp>
            <p:nvSpPr>
              <p:cNvPr id="106" name="217 Rectángulo"/>
              <p:cNvSpPr/>
              <p:nvPr/>
            </p:nvSpPr>
            <p:spPr>
              <a:xfrm>
                <a:off x="1885487" y="6546443"/>
                <a:ext cx="62722" cy="612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07" name="218 CuadroTexto"/>
              <p:cNvSpPr txBox="1"/>
              <p:nvPr/>
            </p:nvSpPr>
            <p:spPr>
              <a:xfrm>
                <a:off x="1902676" y="6466272"/>
                <a:ext cx="8707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YC/PGC1A</a:t>
                </a:r>
              </a:p>
            </p:txBody>
          </p:sp>
        </p:grpSp>
        <p:grpSp>
          <p:nvGrpSpPr>
            <p:cNvPr id="100" name="211 Grupo"/>
            <p:cNvGrpSpPr/>
            <p:nvPr/>
          </p:nvGrpSpPr>
          <p:grpSpPr>
            <a:xfrm>
              <a:off x="3066516" y="6476005"/>
              <a:ext cx="582211" cy="230832"/>
              <a:chOff x="5404239" y="2809271"/>
              <a:chExt cx="582211" cy="230832"/>
            </a:xfrm>
          </p:grpSpPr>
          <p:sp>
            <p:nvSpPr>
              <p:cNvPr id="104" name="215 Rectángulo"/>
              <p:cNvSpPr/>
              <p:nvPr/>
            </p:nvSpPr>
            <p:spPr>
              <a:xfrm>
                <a:off x="5418768" y="2894087"/>
                <a:ext cx="62722" cy="612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05" name="216 CuadroTexto"/>
              <p:cNvSpPr txBox="1"/>
              <p:nvPr/>
            </p:nvSpPr>
            <p:spPr>
              <a:xfrm>
                <a:off x="5404239" y="2809271"/>
                <a:ext cx="5822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GC1A</a:t>
                </a:r>
              </a:p>
            </p:txBody>
          </p:sp>
        </p:grpSp>
        <p:grpSp>
          <p:nvGrpSpPr>
            <p:cNvPr id="101" name="212 Grupo"/>
            <p:cNvGrpSpPr/>
            <p:nvPr/>
          </p:nvGrpSpPr>
          <p:grpSpPr>
            <a:xfrm>
              <a:off x="2512738" y="6476005"/>
              <a:ext cx="449058" cy="230832"/>
              <a:chOff x="5136978" y="2809271"/>
              <a:chExt cx="449058" cy="230832"/>
            </a:xfrm>
          </p:grpSpPr>
          <p:sp>
            <p:nvSpPr>
              <p:cNvPr id="102" name="213 Rectángulo"/>
              <p:cNvSpPr/>
              <p:nvPr/>
            </p:nvSpPr>
            <p:spPr>
              <a:xfrm>
                <a:off x="5136978" y="2894087"/>
                <a:ext cx="62722" cy="612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03" name="214 CuadroTexto"/>
              <p:cNvSpPr txBox="1"/>
              <p:nvPr/>
            </p:nvSpPr>
            <p:spPr>
              <a:xfrm>
                <a:off x="5144890" y="2809271"/>
                <a:ext cx="44114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</a:p>
            </p:txBody>
          </p:sp>
        </p:grpSp>
        <p:sp>
          <p:nvSpPr>
            <p:cNvPr id="139" name="TextBox 9">
              <a:extLst>
                <a:ext uri="{FF2B5EF4-FFF2-40B4-BE49-F238E27FC236}">
                  <a16:creationId xmlns:a16="http://schemas.microsoft.com/office/drawing/2014/main" id="{13164D9F-2C83-3D4E-B261-8BE4B62CFBC6}"/>
                </a:ext>
              </a:extLst>
            </p:cNvPr>
            <p:cNvSpPr txBox="1"/>
            <p:nvPr/>
          </p:nvSpPr>
          <p:spPr>
            <a:xfrm>
              <a:off x="3818507" y="6839642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9">
              <a:extLst>
                <a:ext uri="{FF2B5EF4-FFF2-40B4-BE49-F238E27FC236}">
                  <a16:creationId xmlns:a16="http://schemas.microsoft.com/office/drawing/2014/main" id="{ACBF6A97-7098-F640-BEF7-30A9F97E21FF}"/>
                </a:ext>
              </a:extLst>
            </p:cNvPr>
            <p:cNvSpPr txBox="1"/>
            <p:nvPr/>
          </p:nvSpPr>
          <p:spPr>
            <a:xfrm>
              <a:off x="3591229" y="7054989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9">
              <a:extLst>
                <a:ext uri="{FF2B5EF4-FFF2-40B4-BE49-F238E27FC236}">
                  <a16:creationId xmlns:a16="http://schemas.microsoft.com/office/drawing/2014/main" id="{4ED8FBC4-B44A-BC47-A577-732B250F095A}"/>
                </a:ext>
              </a:extLst>
            </p:cNvPr>
            <p:cNvSpPr txBox="1"/>
            <p:nvPr/>
          </p:nvSpPr>
          <p:spPr>
            <a:xfrm>
              <a:off x="3713960" y="7829465"/>
              <a:ext cx="195623" cy="296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48">
              <a:extLst>
                <a:ext uri="{FF2B5EF4-FFF2-40B4-BE49-F238E27FC236}">
                  <a16:creationId xmlns:a16="http://schemas.microsoft.com/office/drawing/2014/main" id="{5A1E5A63-9406-E442-AFD8-2011B9A4ED4F}"/>
                </a:ext>
              </a:extLst>
            </p:cNvPr>
            <p:cNvSpPr txBox="1"/>
            <p:nvPr/>
          </p:nvSpPr>
          <p:spPr>
            <a:xfrm>
              <a:off x="5467341" y="8120622"/>
              <a:ext cx="341542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48" name="TextBox 5">
              <a:extLst>
                <a:ext uri="{FF2B5EF4-FFF2-40B4-BE49-F238E27FC236}">
                  <a16:creationId xmlns:a16="http://schemas.microsoft.com/office/drawing/2014/main" id="{E42E67FE-12B3-CB4D-B8DE-DBA6D5096D97}"/>
                </a:ext>
              </a:extLst>
            </p:cNvPr>
            <p:cNvSpPr txBox="1"/>
            <p:nvPr/>
          </p:nvSpPr>
          <p:spPr>
            <a:xfrm>
              <a:off x="6301270" y="7383443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0" name="TextBox 9">
              <a:extLst>
                <a:ext uri="{FF2B5EF4-FFF2-40B4-BE49-F238E27FC236}">
                  <a16:creationId xmlns:a16="http://schemas.microsoft.com/office/drawing/2014/main" id="{0C958FF4-32C8-CB4B-9CD0-9E1B46E8D507}"/>
                </a:ext>
              </a:extLst>
            </p:cNvPr>
            <p:cNvSpPr txBox="1"/>
            <p:nvPr/>
          </p:nvSpPr>
          <p:spPr>
            <a:xfrm>
              <a:off x="6412477" y="7982122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2" name="TextBox 9">
              <a:extLst>
                <a:ext uri="{FF2B5EF4-FFF2-40B4-BE49-F238E27FC236}">
                  <a16:creationId xmlns:a16="http://schemas.microsoft.com/office/drawing/2014/main" id="{18C7E5A5-9C55-1545-83D6-108AA65A13B7}"/>
                </a:ext>
              </a:extLst>
            </p:cNvPr>
            <p:cNvSpPr txBox="1"/>
            <p:nvPr/>
          </p:nvSpPr>
          <p:spPr>
            <a:xfrm>
              <a:off x="6068132" y="6941497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3" name="TextBox 38">
              <a:extLst>
                <a:ext uri="{FF2B5EF4-FFF2-40B4-BE49-F238E27FC236}">
                  <a16:creationId xmlns:a16="http://schemas.microsoft.com/office/drawing/2014/main" id="{9922FAC9-6217-5544-A9D2-2503881C4467}"/>
                </a:ext>
              </a:extLst>
            </p:cNvPr>
            <p:cNvSpPr txBox="1"/>
            <p:nvPr/>
          </p:nvSpPr>
          <p:spPr>
            <a:xfrm>
              <a:off x="5143391" y="7270565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5" name="TextBox 38">
              <a:extLst>
                <a:ext uri="{FF2B5EF4-FFF2-40B4-BE49-F238E27FC236}">
                  <a16:creationId xmlns:a16="http://schemas.microsoft.com/office/drawing/2014/main" id="{92985D31-5015-8C4A-9989-ACADCC74D977}"/>
                </a:ext>
              </a:extLst>
            </p:cNvPr>
            <p:cNvSpPr txBox="1"/>
            <p:nvPr/>
          </p:nvSpPr>
          <p:spPr>
            <a:xfrm>
              <a:off x="5834147" y="7459020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6" name="TextBox 38">
              <a:extLst>
                <a:ext uri="{FF2B5EF4-FFF2-40B4-BE49-F238E27FC236}">
                  <a16:creationId xmlns:a16="http://schemas.microsoft.com/office/drawing/2014/main" id="{752983BB-DF38-9145-A0E2-8B1DCDF8923F}"/>
                </a:ext>
              </a:extLst>
            </p:cNvPr>
            <p:cNvSpPr txBox="1"/>
            <p:nvPr/>
          </p:nvSpPr>
          <p:spPr>
            <a:xfrm>
              <a:off x="5374699" y="7139553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7" name="TextBox 38">
              <a:extLst>
                <a:ext uri="{FF2B5EF4-FFF2-40B4-BE49-F238E27FC236}">
                  <a16:creationId xmlns:a16="http://schemas.microsoft.com/office/drawing/2014/main" id="{B88FE08E-C4F9-034E-BEB3-8215D91A7F88}"/>
                </a:ext>
              </a:extLst>
            </p:cNvPr>
            <p:cNvSpPr txBox="1"/>
            <p:nvPr/>
          </p:nvSpPr>
          <p:spPr>
            <a:xfrm>
              <a:off x="6530629" y="7278053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8" name="TextBox 38">
              <a:extLst>
                <a:ext uri="{FF2B5EF4-FFF2-40B4-BE49-F238E27FC236}">
                  <a16:creationId xmlns:a16="http://schemas.microsoft.com/office/drawing/2014/main" id="{3EC68247-58D9-DF4C-8CD8-BE7657ED3C33}"/>
                </a:ext>
              </a:extLst>
            </p:cNvPr>
            <p:cNvSpPr txBox="1"/>
            <p:nvPr/>
          </p:nvSpPr>
          <p:spPr>
            <a:xfrm>
              <a:off x="5021402" y="8197200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45" name="TextBox 38">
              <a:extLst>
                <a:ext uri="{FF2B5EF4-FFF2-40B4-BE49-F238E27FC236}">
                  <a16:creationId xmlns:a16="http://schemas.microsoft.com/office/drawing/2014/main" id="{83CA807F-0E79-1D44-B822-5B30CDAB3AB0}"/>
                </a:ext>
              </a:extLst>
            </p:cNvPr>
            <p:cNvSpPr txBox="1"/>
            <p:nvPr/>
          </p:nvSpPr>
          <p:spPr>
            <a:xfrm>
              <a:off x="5611984" y="7278053"/>
              <a:ext cx="281793" cy="296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3" name="TextBox 74">
            <a:extLst>
              <a:ext uri="{FF2B5EF4-FFF2-40B4-BE49-F238E27FC236}">
                <a16:creationId xmlns:a16="http://schemas.microsoft.com/office/drawing/2014/main" id="{76956E11-BCE7-CF71-970B-E789F50D174D}"/>
              </a:ext>
            </a:extLst>
          </p:cNvPr>
          <p:cNvSpPr txBox="1"/>
          <p:nvPr/>
        </p:nvSpPr>
        <p:spPr>
          <a:xfrm>
            <a:off x="24735" y="694850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pic>
        <p:nvPicPr>
          <p:cNvPr id="8" name="Imagen 7" descr="Gráfico, Gráfico de dispersión&#10;&#10;El contenido generado por IA puede ser incorrecto.">
            <a:extLst>
              <a:ext uri="{FF2B5EF4-FFF2-40B4-BE49-F238E27FC236}">
                <a16:creationId xmlns:a16="http://schemas.microsoft.com/office/drawing/2014/main" id="{79E80AF1-7F6E-EB62-3AE2-6C8FF598406A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22" t="14367" r="12162"/>
          <a:stretch/>
        </p:blipFill>
        <p:spPr>
          <a:xfrm>
            <a:off x="369654" y="7366384"/>
            <a:ext cx="1188426" cy="1323121"/>
          </a:xfrm>
          <a:prstGeom prst="rect">
            <a:avLst/>
          </a:prstGeom>
        </p:spPr>
      </p:pic>
      <p:pic>
        <p:nvPicPr>
          <p:cNvPr id="9" name="Imagen 8" descr="Gráfico, Gráfico de dispersión&#10;&#10;El contenido generado por IA puede ser incorrecto.">
            <a:extLst>
              <a:ext uri="{FF2B5EF4-FFF2-40B4-BE49-F238E27FC236}">
                <a16:creationId xmlns:a16="http://schemas.microsoft.com/office/drawing/2014/main" id="{40E1484D-3B95-7A2D-B73D-396DFD24C715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94" t="15390" r="13185"/>
          <a:stretch/>
        </p:blipFill>
        <p:spPr>
          <a:xfrm>
            <a:off x="2293084" y="7390079"/>
            <a:ext cx="1169960" cy="1307315"/>
          </a:xfrm>
          <a:prstGeom prst="rect">
            <a:avLst/>
          </a:prstGeom>
        </p:spPr>
      </p:pic>
      <p:sp>
        <p:nvSpPr>
          <p:cNvPr id="10" name="TextBox 224">
            <a:extLst>
              <a:ext uri="{FF2B5EF4-FFF2-40B4-BE49-F238E27FC236}">
                <a16:creationId xmlns:a16="http://schemas.microsoft.com/office/drawing/2014/main" id="{81632505-A502-F1CB-BEF2-722385D44B2C}"/>
              </a:ext>
            </a:extLst>
          </p:cNvPr>
          <p:cNvSpPr txBox="1"/>
          <p:nvPr/>
        </p:nvSpPr>
        <p:spPr>
          <a:xfrm>
            <a:off x="836785" y="7173608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</a:p>
        </p:txBody>
      </p:sp>
      <p:sp>
        <p:nvSpPr>
          <p:cNvPr id="11" name="文本框 20">
            <a:extLst>
              <a:ext uri="{FF2B5EF4-FFF2-40B4-BE49-F238E27FC236}">
                <a16:creationId xmlns:a16="http://schemas.microsoft.com/office/drawing/2014/main" id="{F6CBB3A8-22F8-5E34-C2F5-3D964AAE040E}"/>
              </a:ext>
            </a:extLst>
          </p:cNvPr>
          <p:cNvSpPr txBox="1"/>
          <p:nvPr/>
        </p:nvSpPr>
        <p:spPr>
          <a:xfrm rot="16200000">
            <a:off x="1811031" y="7819555"/>
            <a:ext cx="498855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UMAP_2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12" name="TextBox 224">
            <a:extLst>
              <a:ext uri="{FF2B5EF4-FFF2-40B4-BE49-F238E27FC236}">
                <a16:creationId xmlns:a16="http://schemas.microsoft.com/office/drawing/2014/main" id="{F19814FB-2CA8-894E-40E6-90CD563DC889}"/>
              </a:ext>
            </a:extLst>
          </p:cNvPr>
          <p:cNvSpPr txBox="1"/>
          <p:nvPr/>
        </p:nvSpPr>
        <p:spPr>
          <a:xfrm>
            <a:off x="2430367" y="7140836"/>
            <a:ext cx="8963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PARGC1A</a:t>
            </a:r>
          </a:p>
        </p:txBody>
      </p:sp>
      <p:pic>
        <p:nvPicPr>
          <p:cNvPr id="14" name="Imagen 13" descr="Gráfico, Gráfico de dispersión&#10;&#10;El contenido generado por IA puede ser incorrecto.">
            <a:extLst>
              <a:ext uri="{FF2B5EF4-FFF2-40B4-BE49-F238E27FC236}">
                <a16:creationId xmlns:a16="http://schemas.microsoft.com/office/drawing/2014/main" id="{4A78C9A6-1CD0-B147-B617-6CF1559E9754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113" t="36319" r="-168" b="39777"/>
          <a:stretch/>
        </p:blipFill>
        <p:spPr>
          <a:xfrm>
            <a:off x="1575768" y="7678991"/>
            <a:ext cx="246222" cy="532400"/>
          </a:xfrm>
          <a:prstGeom prst="rect">
            <a:avLst/>
          </a:prstGeom>
        </p:spPr>
      </p:pic>
      <p:pic>
        <p:nvPicPr>
          <p:cNvPr id="15" name="Imagen 14" descr="Gráfico, Gráfico de dispersión&#10;&#10;El contenido generado por IA puede ser incorrecto.">
            <a:extLst>
              <a:ext uri="{FF2B5EF4-FFF2-40B4-BE49-F238E27FC236}">
                <a16:creationId xmlns:a16="http://schemas.microsoft.com/office/drawing/2014/main" id="{894629C4-411A-56FA-CCC2-AC6E7D9C0D92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691" t="36221" r="610" b="36350"/>
          <a:stretch/>
        </p:blipFill>
        <p:spPr>
          <a:xfrm>
            <a:off x="3478642" y="7642158"/>
            <a:ext cx="282824" cy="610931"/>
          </a:xfrm>
          <a:prstGeom prst="rect">
            <a:avLst/>
          </a:prstGeom>
        </p:spPr>
      </p:pic>
      <p:sp>
        <p:nvSpPr>
          <p:cNvPr id="17" name="文本框 20">
            <a:extLst>
              <a:ext uri="{FF2B5EF4-FFF2-40B4-BE49-F238E27FC236}">
                <a16:creationId xmlns:a16="http://schemas.microsoft.com/office/drawing/2014/main" id="{A115147C-5511-5E63-1BED-1B396B59064E}"/>
              </a:ext>
            </a:extLst>
          </p:cNvPr>
          <p:cNvSpPr txBox="1"/>
          <p:nvPr/>
        </p:nvSpPr>
        <p:spPr>
          <a:xfrm>
            <a:off x="2651562" y="8697394"/>
            <a:ext cx="498855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UMAP_1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18" name="TextBox 352">
            <a:extLst>
              <a:ext uri="{FF2B5EF4-FFF2-40B4-BE49-F238E27FC236}">
                <a16:creationId xmlns:a16="http://schemas.microsoft.com/office/drawing/2014/main" id="{A500BE7C-25E6-44F2-96D9-01C00CDEF1A0}"/>
              </a:ext>
            </a:extLst>
          </p:cNvPr>
          <p:cNvSpPr txBox="1"/>
          <p:nvPr/>
        </p:nvSpPr>
        <p:spPr>
          <a:xfrm>
            <a:off x="4107340" y="6948509"/>
            <a:ext cx="325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grpSp>
        <p:nvGrpSpPr>
          <p:cNvPr id="19" name="Grupo 18">
            <a:extLst>
              <a:ext uri="{FF2B5EF4-FFF2-40B4-BE49-F238E27FC236}">
                <a16:creationId xmlns:a16="http://schemas.microsoft.com/office/drawing/2014/main" id="{5D762BA0-BA50-271D-84A6-FDBCA8BAD5B1}"/>
              </a:ext>
            </a:extLst>
          </p:cNvPr>
          <p:cNvGrpSpPr/>
          <p:nvPr/>
        </p:nvGrpSpPr>
        <p:grpSpPr>
          <a:xfrm>
            <a:off x="4441802" y="7249553"/>
            <a:ext cx="1717168" cy="1142451"/>
            <a:chOff x="621587" y="3035201"/>
            <a:chExt cx="1878634" cy="1386029"/>
          </a:xfrm>
        </p:grpSpPr>
        <p:grpSp>
          <p:nvGrpSpPr>
            <p:cNvPr id="20" name="Grupo 19">
              <a:extLst>
                <a:ext uri="{FF2B5EF4-FFF2-40B4-BE49-F238E27FC236}">
                  <a16:creationId xmlns:a16="http://schemas.microsoft.com/office/drawing/2014/main" id="{48E1F4CE-C69A-1B9E-469F-834CF07568F2}"/>
                </a:ext>
              </a:extLst>
            </p:cNvPr>
            <p:cNvGrpSpPr/>
            <p:nvPr/>
          </p:nvGrpSpPr>
          <p:grpSpPr>
            <a:xfrm>
              <a:off x="670111" y="3035201"/>
              <a:ext cx="1830110" cy="548576"/>
              <a:chOff x="3545449" y="3101941"/>
              <a:chExt cx="1830110" cy="548576"/>
            </a:xfrm>
          </p:grpSpPr>
          <p:pic>
            <p:nvPicPr>
              <p:cNvPr id="27" name="Imagen 26">
                <a:extLst>
                  <a:ext uri="{FF2B5EF4-FFF2-40B4-BE49-F238E27FC236}">
                    <a16:creationId xmlns:a16="http://schemas.microsoft.com/office/drawing/2014/main" id="{73EBB2D2-F32C-3F48-278F-770B4E891A1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96" t="23243" r="3428" b="8577"/>
              <a:stretch/>
            </p:blipFill>
            <p:spPr>
              <a:xfrm>
                <a:off x="3545449" y="3404238"/>
                <a:ext cx="1182939" cy="24627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8" name="Imagen 27">
                <a:extLst>
                  <a:ext uri="{FF2B5EF4-FFF2-40B4-BE49-F238E27FC236}">
                    <a16:creationId xmlns:a16="http://schemas.microsoft.com/office/drawing/2014/main" id="{59B9221A-1F3C-7D43-6C24-1955444E96E0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3" t="12205" r="2086" b="17864"/>
              <a:stretch/>
            </p:blipFill>
            <p:spPr>
              <a:xfrm>
                <a:off x="3545449" y="3101941"/>
                <a:ext cx="1182939" cy="24627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9" name="CuadroTexto 28">
                <a:extLst>
                  <a:ext uri="{FF2B5EF4-FFF2-40B4-BE49-F238E27FC236}">
                    <a16:creationId xmlns:a16="http://schemas.microsoft.com/office/drawing/2014/main" id="{A01BC224-2299-A6CE-5115-5DCA1E1469ED}"/>
                  </a:ext>
                </a:extLst>
              </p:cNvPr>
              <p:cNvSpPr txBox="1"/>
              <p:nvPr/>
            </p:nvSpPr>
            <p:spPr>
              <a:xfrm>
                <a:off x="4718007" y="3115674"/>
                <a:ext cx="4700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</a:p>
            </p:txBody>
          </p:sp>
          <p:sp>
            <p:nvSpPr>
              <p:cNvPr id="30" name="CuadroTexto 29">
                <a:extLst>
                  <a:ext uri="{FF2B5EF4-FFF2-40B4-BE49-F238E27FC236}">
                    <a16:creationId xmlns:a16="http://schemas.microsoft.com/office/drawing/2014/main" id="{7BDD5973-2B79-2020-0166-E96BADA75CAF}"/>
                  </a:ext>
                </a:extLst>
              </p:cNvPr>
              <p:cNvSpPr txBox="1"/>
              <p:nvPr/>
            </p:nvSpPr>
            <p:spPr>
              <a:xfrm>
                <a:off x="4718007" y="3396431"/>
                <a:ext cx="6575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GC-1</a:t>
                </a:r>
                <a:r>
                  <a:rPr lang="en-US" sz="1000" b="1" dirty="0">
                    <a:latin typeface="Symbol" panose="05050102010706020507" pitchFamily="18" charset="2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pic>
          <p:nvPicPr>
            <p:cNvPr id="21" name="Imagen 20">
              <a:extLst>
                <a:ext uri="{FF2B5EF4-FFF2-40B4-BE49-F238E27FC236}">
                  <a16:creationId xmlns:a16="http://schemas.microsoft.com/office/drawing/2014/main" id="{6F5DCE31-EBB1-B14A-9D8C-8CE2CD24221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2" t="22295" r="4420" b="19371"/>
            <a:stretch/>
          </p:blipFill>
          <p:spPr>
            <a:xfrm>
              <a:off x="665845" y="3646242"/>
              <a:ext cx="1182939" cy="2462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49E58C63-8FA3-5AC0-9130-01ABB7C48D78}"/>
                </a:ext>
              </a:extLst>
            </p:cNvPr>
            <p:cNvSpPr txBox="1"/>
            <p:nvPr/>
          </p:nvSpPr>
          <p:spPr>
            <a:xfrm rot="18800588">
              <a:off x="545284" y="3989362"/>
              <a:ext cx="3834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6187FE8E-5F7F-5C1C-DDE0-FD044915616C}"/>
                </a:ext>
              </a:extLst>
            </p:cNvPr>
            <p:cNvSpPr txBox="1"/>
            <p:nvPr/>
          </p:nvSpPr>
          <p:spPr>
            <a:xfrm rot="18800588">
              <a:off x="793387" y="4027304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F7783DD8-0F49-AE06-5508-B21EBBDDE70F}"/>
                </a:ext>
              </a:extLst>
            </p:cNvPr>
            <p:cNvSpPr txBox="1"/>
            <p:nvPr/>
          </p:nvSpPr>
          <p:spPr>
            <a:xfrm rot="18800588">
              <a:off x="1167466" y="3961381"/>
              <a:ext cx="3706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52E36C0F-8FDB-CD43-43F6-EF8F951C2CBC}"/>
                </a:ext>
              </a:extLst>
            </p:cNvPr>
            <p:cNvSpPr txBox="1"/>
            <p:nvPr/>
          </p:nvSpPr>
          <p:spPr>
            <a:xfrm rot="18800588">
              <a:off x="1343298" y="4000134"/>
              <a:ext cx="589655" cy="252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-165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F451B646-6643-B9AE-3135-BCD3D80344E4}"/>
                </a:ext>
              </a:extLst>
            </p:cNvPr>
            <p:cNvSpPr txBox="1"/>
            <p:nvPr/>
          </p:nvSpPr>
          <p:spPr>
            <a:xfrm>
              <a:off x="1842669" y="3644643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VINC</a:t>
              </a:r>
              <a:endParaRPr lang="en-US" sz="9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</p:grpSp>
      <p:sp>
        <p:nvSpPr>
          <p:cNvPr id="31" name="文本框 20">
            <a:extLst>
              <a:ext uri="{FF2B5EF4-FFF2-40B4-BE49-F238E27FC236}">
                <a16:creationId xmlns:a16="http://schemas.microsoft.com/office/drawing/2014/main" id="{63E994D9-117F-9747-93B9-58D6D251140B}"/>
              </a:ext>
            </a:extLst>
          </p:cNvPr>
          <p:cNvSpPr txBox="1"/>
          <p:nvPr/>
        </p:nvSpPr>
        <p:spPr>
          <a:xfrm>
            <a:off x="2065869" y="7549825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2.5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32" name="文本框 20">
            <a:extLst>
              <a:ext uri="{FF2B5EF4-FFF2-40B4-BE49-F238E27FC236}">
                <a16:creationId xmlns:a16="http://schemas.microsoft.com/office/drawing/2014/main" id="{53DB0582-BF9A-E633-58BD-C66D496E189F}"/>
              </a:ext>
            </a:extLst>
          </p:cNvPr>
          <p:cNvSpPr txBox="1"/>
          <p:nvPr/>
        </p:nvSpPr>
        <p:spPr>
          <a:xfrm>
            <a:off x="2466633" y="8555373"/>
            <a:ext cx="253596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-4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33" name="文本框 20">
            <a:extLst>
              <a:ext uri="{FF2B5EF4-FFF2-40B4-BE49-F238E27FC236}">
                <a16:creationId xmlns:a16="http://schemas.microsoft.com/office/drawing/2014/main" id="{F74EBFB0-2FC0-AED6-DF59-AA532D382BC5}"/>
              </a:ext>
            </a:extLst>
          </p:cNvPr>
          <p:cNvSpPr txBox="1"/>
          <p:nvPr/>
        </p:nvSpPr>
        <p:spPr>
          <a:xfrm>
            <a:off x="3121986" y="8555373"/>
            <a:ext cx="227948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4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34" name="文本框 20">
            <a:extLst>
              <a:ext uri="{FF2B5EF4-FFF2-40B4-BE49-F238E27FC236}">
                <a16:creationId xmlns:a16="http://schemas.microsoft.com/office/drawing/2014/main" id="{6A9A5691-DEEA-C719-5066-F5AA000DA14D}"/>
              </a:ext>
            </a:extLst>
          </p:cNvPr>
          <p:cNvSpPr txBox="1"/>
          <p:nvPr/>
        </p:nvSpPr>
        <p:spPr>
          <a:xfrm>
            <a:off x="2798043" y="8555373"/>
            <a:ext cx="227948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0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35" name="文本框 20">
            <a:extLst>
              <a:ext uri="{FF2B5EF4-FFF2-40B4-BE49-F238E27FC236}">
                <a16:creationId xmlns:a16="http://schemas.microsoft.com/office/drawing/2014/main" id="{29BA38AD-B41A-895D-1A29-7A1C1234B291}"/>
              </a:ext>
            </a:extLst>
          </p:cNvPr>
          <p:cNvSpPr txBox="1"/>
          <p:nvPr/>
        </p:nvSpPr>
        <p:spPr>
          <a:xfrm>
            <a:off x="2065869" y="7871444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0.0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36" name="文本框 20">
            <a:extLst>
              <a:ext uri="{FF2B5EF4-FFF2-40B4-BE49-F238E27FC236}">
                <a16:creationId xmlns:a16="http://schemas.microsoft.com/office/drawing/2014/main" id="{03D5C433-17A1-3434-F8AD-3F3858EDA43A}"/>
              </a:ext>
            </a:extLst>
          </p:cNvPr>
          <p:cNvSpPr txBox="1"/>
          <p:nvPr/>
        </p:nvSpPr>
        <p:spPr>
          <a:xfrm>
            <a:off x="2040221" y="8199260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-2.5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37" name="文本框 20">
            <a:extLst>
              <a:ext uri="{FF2B5EF4-FFF2-40B4-BE49-F238E27FC236}">
                <a16:creationId xmlns:a16="http://schemas.microsoft.com/office/drawing/2014/main" id="{39A1122A-7328-668B-27D0-CD73CC6B6FE3}"/>
              </a:ext>
            </a:extLst>
          </p:cNvPr>
          <p:cNvSpPr txBox="1"/>
          <p:nvPr/>
        </p:nvSpPr>
        <p:spPr>
          <a:xfrm rot="16200000">
            <a:off x="-95477" y="7799371"/>
            <a:ext cx="498855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UMAP_2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38" name="文本框 20">
            <a:extLst>
              <a:ext uri="{FF2B5EF4-FFF2-40B4-BE49-F238E27FC236}">
                <a16:creationId xmlns:a16="http://schemas.microsoft.com/office/drawing/2014/main" id="{C9190B15-2637-54E7-ECA7-C892DF2143FC}"/>
              </a:ext>
            </a:extLst>
          </p:cNvPr>
          <p:cNvSpPr txBox="1"/>
          <p:nvPr/>
        </p:nvSpPr>
        <p:spPr>
          <a:xfrm>
            <a:off x="159361" y="7529641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2.5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39" name="文本框 20">
            <a:extLst>
              <a:ext uri="{FF2B5EF4-FFF2-40B4-BE49-F238E27FC236}">
                <a16:creationId xmlns:a16="http://schemas.microsoft.com/office/drawing/2014/main" id="{EF6F8465-79A8-6D6A-CA54-0241D7DEB516}"/>
              </a:ext>
            </a:extLst>
          </p:cNvPr>
          <p:cNvSpPr txBox="1"/>
          <p:nvPr/>
        </p:nvSpPr>
        <p:spPr>
          <a:xfrm>
            <a:off x="159361" y="7851260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0.0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40" name="文本框 20">
            <a:extLst>
              <a:ext uri="{FF2B5EF4-FFF2-40B4-BE49-F238E27FC236}">
                <a16:creationId xmlns:a16="http://schemas.microsoft.com/office/drawing/2014/main" id="{2E37C943-365A-36FF-7111-0F693576D845}"/>
              </a:ext>
            </a:extLst>
          </p:cNvPr>
          <p:cNvSpPr txBox="1"/>
          <p:nvPr/>
        </p:nvSpPr>
        <p:spPr>
          <a:xfrm>
            <a:off x="133713" y="8179076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-2.5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41" name="文本框 20">
            <a:extLst>
              <a:ext uri="{FF2B5EF4-FFF2-40B4-BE49-F238E27FC236}">
                <a16:creationId xmlns:a16="http://schemas.microsoft.com/office/drawing/2014/main" id="{563785C6-61A1-C0F3-EB77-56FE9A213076}"/>
              </a:ext>
            </a:extLst>
          </p:cNvPr>
          <p:cNvSpPr txBox="1"/>
          <p:nvPr/>
        </p:nvSpPr>
        <p:spPr>
          <a:xfrm>
            <a:off x="741515" y="8697394"/>
            <a:ext cx="498855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UMAP_1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42" name="文本框 20">
            <a:extLst>
              <a:ext uri="{FF2B5EF4-FFF2-40B4-BE49-F238E27FC236}">
                <a16:creationId xmlns:a16="http://schemas.microsoft.com/office/drawing/2014/main" id="{692B56E6-CA1D-626D-8B93-0682CBB48302}"/>
              </a:ext>
            </a:extLst>
          </p:cNvPr>
          <p:cNvSpPr txBox="1"/>
          <p:nvPr/>
        </p:nvSpPr>
        <p:spPr>
          <a:xfrm>
            <a:off x="550530" y="8555373"/>
            <a:ext cx="253596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-4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43" name="文本框 20">
            <a:extLst>
              <a:ext uri="{FF2B5EF4-FFF2-40B4-BE49-F238E27FC236}">
                <a16:creationId xmlns:a16="http://schemas.microsoft.com/office/drawing/2014/main" id="{2E1F3AB8-DD35-E4B4-4048-7570666666A2}"/>
              </a:ext>
            </a:extLst>
          </p:cNvPr>
          <p:cNvSpPr txBox="1"/>
          <p:nvPr/>
        </p:nvSpPr>
        <p:spPr>
          <a:xfrm>
            <a:off x="1227079" y="8555373"/>
            <a:ext cx="227948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4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sp>
        <p:nvSpPr>
          <p:cNvPr id="44" name="文本框 20">
            <a:extLst>
              <a:ext uri="{FF2B5EF4-FFF2-40B4-BE49-F238E27FC236}">
                <a16:creationId xmlns:a16="http://schemas.microsoft.com/office/drawing/2014/main" id="{4E948E0C-6209-7FFA-F1AE-6FB32DE1CFB7}"/>
              </a:ext>
            </a:extLst>
          </p:cNvPr>
          <p:cNvSpPr txBox="1"/>
          <p:nvPr/>
        </p:nvSpPr>
        <p:spPr>
          <a:xfrm>
            <a:off x="876149" y="8555373"/>
            <a:ext cx="288243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0</a:t>
            </a:r>
            <a:endParaRPr lang="zh-CN" altLang="en-US" sz="600" b="1" dirty="0"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75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32</Words>
  <Application>Microsoft Office PowerPoint</Application>
  <PresentationFormat>Presentación en pantalla (4:3)</PresentationFormat>
  <Paragraphs>77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tricia sancho</cp:lastModifiedBy>
  <cp:revision>961</cp:revision>
  <cp:lastPrinted>2020-07-03T05:57:45Z</cp:lastPrinted>
  <dcterms:created xsi:type="dcterms:W3CDTF">2016-12-14T11:07:19Z</dcterms:created>
  <dcterms:modified xsi:type="dcterms:W3CDTF">2025-07-11T17:18:25Z</dcterms:modified>
</cp:coreProperties>
</file>